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58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13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7AC7-EF6A-43F2-982F-1E44FCD0778C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9EB80-8F2F-488C-873A-D6C7CD65C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45611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7AC7-EF6A-43F2-982F-1E44FCD0778C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9EB80-8F2F-488C-873A-D6C7CD65C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7223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7AC7-EF6A-43F2-982F-1E44FCD0778C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9EB80-8F2F-488C-873A-D6C7CD65C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85978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7AC7-EF6A-43F2-982F-1E44FCD0778C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9EB80-8F2F-488C-873A-D6C7CD65C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70704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7AC7-EF6A-43F2-982F-1E44FCD0778C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9EB80-8F2F-488C-873A-D6C7CD65C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6331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7AC7-EF6A-43F2-982F-1E44FCD0778C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9EB80-8F2F-488C-873A-D6C7CD65C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5352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7AC7-EF6A-43F2-982F-1E44FCD0778C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9EB80-8F2F-488C-873A-D6C7CD65C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4249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7AC7-EF6A-43F2-982F-1E44FCD0778C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9EB80-8F2F-488C-873A-D6C7CD65C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6402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7AC7-EF6A-43F2-982F-1E44FCD0778C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9EB80-8F2F-488C-873A-D6C7CD65C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5024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7AC7-EF6A-43F2-982F-1E44FCD0778C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9EB80-8F2F-488C-873A-D6C7CD65C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44588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7AC7-EF6A-43F2-982F-1E44FCD0778C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9EB80-8F2F-488C-873A-D6C7CD65C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2190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E47AC7-EF6A-43F2-982F-1E44FCD0778C}" type="datetimeFigureOut">
              <a:rPr kumimoji="1" lang="ja-JP" altLang="en-US" smtClean="0"/>
              <a:t>2019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B9EB80-8F2F-488C-873A-D6C7CD65C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0073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/>
          <p:cNvSpPr txBox="1"/>
          <p:nvPr/>
        </p:nvSpPr>
        <p:spPr>
          <a:xfrm>
            <a:off x="6421504" y="2375454"/>
            <a:ext cx="84899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dirty="0"/>
              <a:t>P</a:t>
            </a:r>
            <a:r>
              <a:rPr kumimoji="1" lang="ja-JP" altLang="en-US" sz="1350" dirty="0"/>
              <a:t> </a:t>
            </a:r>
            <a:r>
              <a:rPr kumimoji="1" lang="en-US" altLang="ja-JP" sz="1350" dirty="0"/>
              <a:t>=</a:t>
            </a:r>
            <a:r>
              <a:rPr kumimoji="1" lang="ja-JP" altLang="en-US" sz="1350" dirty="0"/>
              <a:t> </a:t>
            </a:r>
            <a:r>
              <a:rPr kumimoji="1" lang="en-US" altLang="ja-JP" sz="1350" dirty="0"/>
              <a:t>0.002</a:t>
            </a:r>
            <a:endParaRPr kumimoji="1" lang="ja-JP" altLang="en-US" sz="1350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4859383" y="1777494"/>
            <a:ext cx="400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itchFamily="34" charset="0"/>
                <a:cs typeface="Arial" pitchFamily="34" charset="0"/>
              </a:rPr>
              <a:t>B</a:t>
            </a:r>
            <a:endParaRPr kumimoji="1" lang="ja-JP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テキストボックス 18"/>
          <p:cNvSpPr txBox="1"/>
          <p:nvPr/>
        </p:nvSpPr>
        <p:spPr>
          <a:xfrm>
            <a:off x="4394327" y="1876425"/>
            <a:ext cx="321310" cy="3324225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ja-JP" sz="900" b="1" dirty="0">
                <a:sym typeface="+mn-ea"/>
              </a:rPr>
              <a:t>Cumulative survival probability</a:t>
            </a:r>
            <a:endParaRPr lang="ja-JP" altLang="en-US" sz="900" b="1" dirty="0"/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47F27263-D346-4446-930F-8849E3AFA1E6}"/>
              </a:ext>
            </a:extLst>
          </p:cNvPr>
          <p:cNvSpPr/>
          <p:nvPr/>
        </p:nvSpPr>
        <p:spPr>
          <a:xfrm>
            <a:off x="8072985" y="2682159"/>
            <a:ext cx="769263" cy="9845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20" name="図 19">
            <a:extLst>
              <a:ext uri="{FF2B5EF4-FFF2-40B4-BE49-F238E27FC236}">
                <a16:creationId xmlns:a16="http://schemas.microsoft.com/office/drawing/2014/main" id="{AA85F662-66DA-40F0-B9A1-7A8B5CF0AE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90372" y="744289"/>
            <a:ext cx="6747772" cy="4520282"/>
          </a:xfrm>
          <a:prstGeom prst="rect">
            <a:avLst/>
          </a:prstGeom>
        </p:spPr>
      </p:pic>
      <p:sp>
        <p:nvSpPr>
          <p:cNvPr id="13" name="テキスト ボックス 6"/>
          <p:cNvSpPr txBox="1"/>
          <p:nvPr/>
        </p:nvSpPr>
        <p:spPr>
          <a:xfrm>
            <a:off x="6552031" y="986697"/>
            <a:ext cx="153638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IMMT expression</a:t>
            </a:r>
            <a:endParaRPr kumimoji="1" lang="ja-JP" altLang="en-US" sz="1200" b="1" dirty="0"/>
          </a:p>
        </p:txBody>
      </p:sp>
      <p:sp>
        <p:nvSpPr>
          <p:cNvPr id="15" name="テキストボックス 14"/>
          <p:cNvSpPr txBox="1"/>
          <p:nvPr/>
        </p:nvSpPr>
        <p:spPr>
          <a:xfrm>
            <a:off x="3576904" y="4579932"/>
            <a:ext cx="190119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/>
              <a:t>Years after surgery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4660D7C-2932-4771-8AAC-6DD605422C40}"/>
              </a:ext>
            </a:extLst>
          </p:cNvPr>
          <p:cNvSpPr txBox="1"/>
          <p:nvPr/>
        </p:nvSpPr>
        <p:spPr>
          <a:xfrm>
            <a:off x="5552959" y="955919"/>
            <a:ext cx="10739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P=0.001</a:t>
            </a:r>
            <a:endParaRPr kumimoji="1" lang="ja-JP" altLang="en-US" sz="14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3EA464A-0670-478E-96A6-8AF335AD5986}"/>
              </a:ext>
            </a:extLst>
          </p:cNvPr>
          <p:cNvSpPr txBox="1"/>
          <p:nvPr/>
        </p:nvSpPr>
        <p:spPr>
          <a:xfrm>
            <a:off x="1698171" y="5050971"/>
            <a:ext cx="645305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Supplementary Fig. 2.</a:t>
            </a:r>
          </a:p>
          <a:p>
            <a:r>
              <a:rPr kumimoji="1" lang="en-US" altLang="ja-JP" sz="1200" dirty="0"/>
              <a:t>Cumulative survival of patients with lung adenocarcinoma estimated by the Kaplan–Meier method. Patients with other causes of death and those lost to follow-up were treated as censored cases. In all 165 patients with resected lung adenocarcinoma excluding the micropapillary subtype. IMMT expression was significantly correlated with poorer survival in patients with lung adenocarcinoma (</a:t>
            </a:r>
            <a:r>
              <a:rPr kumimoji="1" lang="en-US" altLang="ja-JP" sz="1200" i="1" dirty="0"/>
              <a:t>P </a:t>
            </a:r>
            <a:r>
              <a:rPr kumimoji="1" lang="en-US" altLang="ja-JP" sz="1200" dirty="0"/>
              <a:t>= 0.001). The 5-year cumulative survival probability for higher IMMT and lower IMMT expression groups were 67% and 82%, respectively.</a:t>
            </a:r>
            <a:endParaRPr kumimoji="1" lang="ja-JP" altLang="en-US" sz="1200" dirty="0"/>
          </a:p>
        </p:txBody>
      </p:sp>
      <p:sp>
        <p:nvSpPr>
          <p:cNvPr id="12" name="テキストボックス 17">
            <a:extLst>
              <a:ext uri="{FF2B5EF4-FFF2-40B4-BE49-F238E27FC236}">
                <a16:creationId xmlns:a16="http://schemas.microsoft.com/office/drawing/2014/main" id="{9E0AF656-2E39-4B65-8C28-858A513F3CA7}"/>
              </a:ext>
            </a:extLst>
          </p:cNvPr>
          <p:cNvSpPr txBox="1"/>
          <p:nvPr/>
        </p:nvSpPr>
        <p:spPr>
          <a:xfrm>
            <a:off x="1328839" y="986697"/>
            <a:ext cx="369332" cy="3324225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ja-JP" sz="1200" b="1" dirty="0">
                <a:sym typeface="+mn-ea"/>
              </a:rPr>
              <a:t>Cumulative survival probability</a:t>
            </a:r>
            <a:endParaRPr lang="ja-JP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1588241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</TotalTime>
  <Words>107</Words>
  <Application>Microsoft Office PowerPoint</Application>
  <PresentationFormat>画面に合わせる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雄一</dc:creator>
  <cp:lastModifiedBy>佐藤 雄一</cp:lastModifiedBy>
  <cp:revision>7</cp:revision>
  <dcterms:created xsi:type="dcterms:W3CDTF">2019-07-16T02:13:37Z</dcterms:created>
  <dcterms:modified xsi:type="dcterms:W3CDTF">2019-09-02T07:07:32Z</dcterms:modified>
</cp:coreProperties>
</file>